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60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72" autoAdjust="0"/>
    <p:restoredTop sz="94660"/>
  </p:normalViewPr>
  <p:slideViewPr>
    <p:cSldViewPr snapToGrid="0">
      <p:cViewPr varScale="1">
        <p:scale>
          <a:sx n="90" d="100"/>
          <a:sy n="90" d="100"/>
        </p:scale>
        <p:origin x="474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26387978-3539-4B26-8454-98DD5354961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DC95860D-E79A-470C-AF03-E5905D0655F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40650B8E-36CD-45C4-AD18-3C39DC47D9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2C8822-BBAB-4A61-9902-BF51D6337433}" type="datetimeFigureOut">
              <a:rPr lang="fr-FR" smtClean="0"/>
              <a:t>18/09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50331BF0-EF17-40AA-9C3B-70AAD5F22A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ADB97DD4-9F35-4D87-964F-18B5644854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242957-6E2F-40C7-A62C-1400C7E8FB4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318641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F321F7C2-1145-47DB-ADCD-8D008CDA0F0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D40C4E0E-9294-487A-B68A-5DA38FBCFA3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6D45A5D4-3A8A-4A84-BFFB-871CB4780C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2C8822-BBAB-4A61-9902-BF51D6337433}" type="datetimeFigureOut">
              <a:rPr lang="fr-FR" smtClean="0"/>
              <a:t>18/09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125D787A-28F8-4D8A-9B38-D4C776A349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709311B2-5718-4374-A05C-53EA37A922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242957-6E2F-40C7-A62C-1400C7E8FB4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629342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690315EA-8F14-4FB8-A78D-BA9E62BC85C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651B2BC6-92CE-4956-BD86-0DA0132634A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120349F1-A9BB-4B86-B42A-88BBD7E201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2C8822-BBAB-4A61-9902-BF51D6337433}" type="datetimeFigureOut">
              <a:rPr lang="fr-FR" smtClean="0"/>
              <a:t>18/09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B03A526A-AFDD-4043-ADC2-B883CB57CF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EA1AB495-F1A3-4F1F-9AD2-2148D0454E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242957-6E2F-40C7-A62C-1400C7E8FB4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859650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E1289996-3E6E-462F-ADE8-219B28EA9D0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FD2B0F7E-3C11-4C15-A97A-AE6DEB84F04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04F2FDA4-DD14-4B27-985A-A49AEB34AE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2C8822-BBAB-4A61-9902-BF51D6337433}" type="datetimeFigureOut">
              <a:rPr lang="fr-FR" smtClean="0"/>
              <a:t>18/09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8E17C7DD-93F2-490B-9523-6FE368AE59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FF80646B-D1F4-4CD0-B226-90BC2B68A1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242957-6E2F-40C7-A62C-1400C7E8FB4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166594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2D587434-BA00-43B6-BFF0-2180E0E5D9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173F86F1-6BD2-418B-BF96-0762FA4E488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9CEAE546-C4C6-43D7-9FB0-9B1CE3B743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2C8822-BBAB-4A61-9902-BF51D6337433}" type="datetimeFigureOut">
              <a:rPr lang="fr-FR" smtClean="0"/>
              <a:t>18/09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CA02C0F1-FF6F-4194-8942-8727806FA2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166A7B4B-08DC-4358-8657-296E85336F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242957-6E2F-40C7-A62C-1400C7E8FB4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039903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42031566-8268-474E-AC98-253F600B11B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B7E45E34-814E-4303-9417-783265899CA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45B13670-7DD8-4A18-AE64-421D72E72B9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62D55666-DE1B-49A3-BD28-0B2369988F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2C8822-BBAB-4A61-9902-BF51D6337433}" type="datetimeFigureOut">
              <a:rPr lang="fr-FR" smtClean="0"/>
              <a:t>18/09/2020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0DB2E1A9-FB5F-4006-A267-B91108070D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CE7CB439-84A0-4063-ACDC-4ADC79B22F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242957-6E2F-40C7-A62C-1400C7E8FB4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155172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0518F9B5-840F-45CB-81F2-4981D9E2611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5E9B6563-9D48-46F9-8066-EBA8DCE4CE8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11E4FBCE-AC54-4772-B204-23F2971771E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99EA52ED-3992-4A4F-9AA9-4C730167680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9FEA1A32-3DE6-46EA-9BE4-61B9FD7ED1A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1C8F6F13-A15D-4B7A-9C81-05E683A0AF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2C8822-BBAB-4A61-9902-BF51D6337433}" type="datetimeFigureOut">
              <a:rPr lang="fr-FR" smtClean="0"/>
              <a:t>18/09/2020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F760FC90-B9FE-4C28-BC48-7D58010BB0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0B26930F-888E-4882-82DD-B4D3A2D3D3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242957-6E2F-40C7-A62C-1400C7E8FB4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408781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A326B24E-5ABD-4184-9754-0DB842D2FAF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6C0738F0-E65F-4821-8A00-7CA9A9347D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2C8822-BBAB-4A61-9902-BF51D6337433}" type="datetimeFigureOut">
              <a:rPr lang="fr-FR" smtClean="0"/>
              <a:t>18/09/2020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9CE058C9-FABF-462E-84F1-8516D8F920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F1C065C6-54FF-4934-9EF9-16AC57A48B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242957-6E2F-40C7-A62C-1400C7E8FB4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823370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96078D38-A639-4552-A60D-7AD26CB201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2C8822-BBAB-4A61-9902-BF51D6337433}" type="datetimeFigureOut">
              <a:rPr lang="fr-FR" smtClean="0"/>
              <a:t>18/09/2020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0E13928B-CC8C-4C97-B2AB-B9EB7F7490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CD034BA4-A6BE-4F9A-B73D-8212BA2D8C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242957-6E2F-40C7-A62C-1400C7E8FB4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534410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65B73F3B-99D5-4F47-A0B9-F199F30BAB4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184CC580-795C-4BCA-B6BF-9C50E653B0B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6AE4A1F5-A08D-43F4-B3F7-A02EBF6869C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64520787-F9D4-487D-842B-450E9A1BF6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2C8822-BBAB-4A61-9902-BF51D6337433}" type="datetimeFigureOut">
              <a:rPr lang="fr-FR" smtClean="0"/>
              <a:t>18/09/2020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A0107953-4D08-4EE1-8189-3B217FE11A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C173DD52-6E6C-4C29-9A52-E786713AFF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242957-6E2F-40C7-A62C-1400C7E8FB4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213660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13390927-CFE4-41E4-ACC1-B639C891A15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A23B05C6-A59E-4B8F-B34A-B0CD431053C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FD207958-6B38-4B78-8666-8FF741AF3FA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A0878948-C419-47D1-A157-1613532035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2C8822-BBAB-4A61-9902-BF51D6337433}" type="datetimeFigureOut">
              <a:rPr lang="fr-FR" smtClean="0"/>
              <a:t>18/09/2020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11DC0E87-C45F-4198-8137-AA72FB859F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B6D01CA4-DEDD-444F-BEEC-F4B4BC78A9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242957-6E2F-40C7-A62C-1400C7E8FB4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843810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A95D8DFE-4774-4573-BA2F-04B15434C82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33F822B6-421B-4C2A-86BF-9BF09D232DD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FD3B616B-5F18-4893-B6CB-EC8638E956B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52C8822-BBAB-4A61-9902-BF51D6337433}" type="datetimeFigureOut">
              <a:rPr lang="fr-FR" smtClean="0"/>
              <a:t>18/09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55304C65-D4ED-4842-ADC5-437E1232CF1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75F49AE8-E925-46B5-99F1-04B6D55BF87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242957-6E2F-40C7-A62C-1400C7E8FB4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638495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e 4">
            <a:extLst>
              <a:ext uri="{FF2B5EF4-FFF2-40B4-BE49-F238E27FC236}">
                <a16:creationId xmlns:a16="http://schemas.microsoft.com/office/drawing/2014/main" id="{22D318E2-4830-4941-AFCB-63FD324FAF64}"/>
              </a:ext>
            </a:extLst>
          </p:cNvPr>
          <p:cNvGrpSpPr/>
          <p:nvPr/>
        </p:nvGrpSpPr>
        <p:grpSpPr>
          <a:xfrm>
            <a:off x="207579" y="247680"/>
            <a:ext cx="11617496" cy="6037484"/>
            <a:chOff x="102479" y="247680"/>
            <a:chExt cx="11617496" cy="6037484"/>
          </a:xfrm>
        </p:grpSpPr>
        <p:sp>
          <p:nvSpPr>
            <p:cNvPr id="2" name="ZoneTexte 1">
              <a:extLst>
                <a:ext uri="{FF2B5EF4-FFF2-40B4-BE49-F238E27FC236}">
                  <a16:creationId xmlns:a16="http://schemas.microsoft.com/office/drawing/2014/main" id="{CA026455-A9BB-42DE-AD65-8D304DD61675}"/>
                </a:ext>
              </a:extLst>
            </p:cNvPr>
            <p:cNvSpPr txBox="1"/>
            <p:nvPr/>
          </p:nvSpPr>
          <p:spPr>
            <a:xfrm>
              <a:off x="303658" y="247680"/>
              <a:ext cx="201237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400" b="1" dirty="0" err="1"/>
                <a:t>Uninfected</a:t>
              </a:r>
              <a:r>
                <a:rPr lang="fr-FR" sz="1400" b="1" dirty="0"/>
                <a:t> </a:t>
              </a:r>
              <a:r>
                <a:rPr lang="fr-FR" sz="1400" b="1" dirty="0" err="1"/>
                <a:t>chicks</a:t>
              </a:r>
              <a:endParaRPr lang="fr-FR" sz="1400" b="1" dirty="0"/>
            </a:p>
          </p:txBody>
        </p:sp>
        <p:sp>
          <p:nvSpPr>
            <p:cNvPr id="3" name="ZoneTexte 2">
              <a:extLst>
                <a:ext uri="{FF2B5EF4-FFF2-40B4-BE49-F238E27FC236}">
                  <a16:creationId xmlns:a16="http://schemas.microsoft.com/office/drawing/2014/main" id="{7D068381-654B-455A-8AD6-DD61C7C23104}"/>
                </a:ext>
              </a:extLst>
            </p:cNvPr>
            <p:cNvSpPr txBox="1"/>
            <p:nvPr/>
          </p:nvSpPr>
          <p:spPr>
            <a:xfrm>
              <a:off x="5609964" y="5094732"/>
              <a:ext cx="179614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 err="1"/>
                <a:t>Labeled</a:t>
              </a:r>
              <a:r>
                <a:rPr lang="fr-FR" sz="1200" dirty="0"/>
                <a:t> thrombocytes</a:t>
              </a:r>
            </a:p>
          </p:txBody>
        </p:sp>
        <p:sp>
          <p:nvSpPr>
            <p:cNvPr id="22" name="ZoneTexte 21">
              <a:extLst>
                <a:ext uri="{FF2B5EF4-FFF2-40B4-BE49-F238E27FC236}">
                  <a16:creationId xmlns:a16="http://schemas.microsoft.com/office/drawing/2014/main" id="{3E095E98-FB10-4632-ABAC-8D5D7E24BB14}"/>
                </a:ext>
              </a:extLst>
            </p:cNvPr>
            <p:cNvSpPr txBox="1"/>
            <p:nvPr/>
          </p:nvSpPr>
          <p:spPr>
            <a:xfrm>
              <a:off x="9218647" y="2882293"/>
              <a:ext cx="230299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 err="1"/>
                <a:t>Infected</a:t>
              </a:r>
              <a:r>
                <a:rPr lang="fr-FR" sz="1200" dirty="0"/>
                <a:t> </a:t>
              </a:r>
              <a:r>
                <a:rPr lang="fr-FR" sz="1200" dirty="0" err="1"/>
                <a:t>labeled</a:t>
              </a:r>
              <a:r>
                <a:rPr lang="fr-FR" sz="1200" dirty="0"/>
                <a:t> thrombocytes</a:t>
              </a:r>
            </a:p>
          </p:txBody>
        </p:sp>
        <p:sp>
          <p:nvSpPr>
            <p:cNvPr id="24" name="ZoneTexte 23">
              <a:extLst>
                <a:ext uri="{FF2B5EF4-FFF2-40B4-BE49-F238E27FC236}">
                  <a16:creationId xmlns:a16="http://schemas.microsoft.com/office/drawing/2014/main" id="{98F442FB-E16F-48C2-8300-436C8FCB20B1}"/>
                </a:ext>
              </a:extLst>
            </p:cNvPr>
            <p:cNvSpPr txBox="1"/>
            <p:nvPr/>
          </p:nvSpPr>
          <p:spPr>
            <a:xfrm>
              <a:off x="254879" y="2079450"/>
              <a:ext cx="20123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400" b="1" dirty="0" err="1"/>
                <a:t>Infected</a:t>
              </a:r>
              <a:r>
                <a:rPr lang="fr-FR" sz="1400" b="1" dirty="0"/>
                <a:t> </a:t>
              </a:r>
              <a:r>
                <a:rPr lang="fr-FR" sz="1400" b="1" dirty="0" err="1"/>
                <a:t>chicks</a:t>
              </a:r>
              <a:r>
                <a:rPr lang="fr-FR" sz="1400" b="1" dirty="0"/>
                <a:t> by the </a:t>
              </a:r>
              <a:r>
                <a:rPr lang="fr-FR" sz="1400" b="1" dirty="0" err="1"/>
                <a:t>wild</a:t>
              </a:r>
              <a:r>
                <a:rPr lang="fr-FR" sz="1400" b="1" dirty="0"/>
                <a:t>-type </a:t>
              </a:r>
              <a:r>
                <a:rPr lang="fr-FR" sz="1400" b="1" dirty="0" err="1"/>
                <a:t>strain</a:t>
              </a:r>
              <a:endParaRPr lang="fr-FR" sz="1400" b="1" dirty="0"/>
            </a:p>
          </p:txBody>
        </p:sp>
        <p:sp>
          <p:nvSpPr>
            <p:cNvPr id="26" name="ZoneTexte 25">
              <a:extLst>
                <a:ext uri="{FF2B5EF4-FFF2-40B4-BE49-F238E27FC236}">
                  <a16:creationId xmlns:a16="http://schemas.microsoft.com/office/drawing/2014/main" id="{B679AC25-A109-4D68-AE69-D05E667E6BF3}"/>
                </a:ext>
              </a:extLst>
            </p:cNvPr>
            <p:cNvSpPr txBox="1"/>
            <p:nvPr/>
          </p:nvSpPr>
          <p:spPr>
            <a:xfrm>
              <a:off x="9218647" y="3794041"/>
              <a:ext cx="248349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 err="1"/>
                <a:t>Infected</a:t>
              </a:r>
              <a:r>
                <a:rPr lang="fr-FR" sz="1200" dirty="0"/>
                <a:t> </a:t>
              </a:r>
              <a:r>
                <a:rPr lang="fr-FR" sz="1200" dirty="0" err="1"/>
                <a:t>unlabeled</a:t>
              </a:r>
              <a:r>
                <a:rPr lang="fr-FR" sz="1200" dirty="0"/>
                <a:t> </a:t>
              </a:r>
              <a:r>
                <a:rPr lang="fr-FR" sz="1200" dirty="0" err="1"/>
                <a:t>cells</a:t>
              </a:r>
              <a:endParaRPr lang="fr-FR" sz="1200" dirty="0"/>
            </a:p>
          </p:txBody>
        </p:sp>
        <p:sp>
          <p:nvSpPr>
            <p:cNvPr id="27" name="ZoneTexte 26">
              <a:extLst>
                <a:ext uri="{FF2B5EF4-FFF2-40B4-BE49-F238E27FC236}">
                  <a16:creationId xmlns:a16="http://schemas.microsoft.com/office/drawing/2014/main" id="{01D3C4F2-309A-4C18-BF71-65F2682EA3EF}"/>
                </a:ext>
              </a:extLst>
            </p:cNvPr>
            <p:cNvSpPr txBox="1"/>
            <p:nvPr/>
          </p:nvSpPr>
          <p:spPr>
            <a:xfrm>
              <a:off x="102479" y="4452022"/>
              <a:ext cx="253784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400" b="1" dirty="0" err="1"/>
                <a:t>Infected</a:t>
              </a:r>
              <a:r>
                <a:rPr lang="fr-FR" sz="1400" b="1" dirty="0"/>
                <a:t> </a:t>
              </a:r>
              <a:r>
                <a:rPr lang="fr-FR" sz="1400" b="1" dirty="0" err="1"/>
                <a:t>chicks</a:t>
              </a:r>
              <a:r>
                <a:rPr lang="fr-FR" sz="1400" b="1" dirty="0"/>
                <a:t> by the 3</a:t>
              </a:r>
              <a:r>
                <a:rPr lang="el-GR" sz="1400" b="1" dirty="0"/>
                <a:t>Δ</a:t>
              </a:r>
              <a:r>
                <a:rPr lang="fr-FR" sz="1400" b="1" dirty="0"/>
                <a:t> </a:t>
              </a:r>
              <a:r>
                <a:rPr lang="fr-FR" sz="1400" b="1" dirty="0" err="1"/>
                <a:t>strain</a:t>
              </a:r>
              <a:endParaRPr lang="fr-FR" sz="1400" b="1" dirty="0"/>
            </a:p>
          </p:txBody>
        </p:sp>
        <p:sp>
          <p:nvSpPr>
            <p:cNvPr id="28" name="ZoneTexte 27">
              <a:extLst>
                <a:ext uri="{FF2B5EF4-FFF2-40B4-BE49-F238E27FC236}">
                  <a16:creationId xmlns:a16="http://schemas.microsoft.com/office/drawing/2014/main" id="{2C50DD77-AD82-4A09-9D1B-BA65F43B8CE2}"/>
                </a:ext>
              </a:extLst>
            </p:cNvPr>
            <p:cNvSpPr txBox="1"/>
            <p:nvPr/>
          </p:nvSpPr>
          <p:spPr>
            <a:xfrm>
              <a:off x="5633519" y="2819840"/>
              <a:ext cx="179614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 err="1"/>
                <a:t>Labeled</a:t>
              </a:r>
              <a:r>
                <a:rPr lang="fr-FR" sz="1200" dirty="0"/>
                <a:t> thrombocytes</a:t>
              </a:r>
            </a:p>
          </p:txBody>
        </p:sp>
        <p:sp>
          <p:nvSpPr>
            <p:cNvPr id="31" name="ZoneTexte 30">
              <a:extLst>
                <a:ext uri="{FF2B5EF4-FFF2-40B4-BE49-F238E27FC236}">
                  <a16:creationId xmlns:a16="http://schemas.microsoft.com/office/drawing/2014/main" id="{1385067D-7DB2-4E0E-89AA-BA4E85F051C4}"/>
                </a:ext>
              </a:extLst>
            </p:cNvPr>
            <p:cNvSpPr txBox="1"/>
            <p:nvPr/>
          </p:nvSpPr>
          <p:spPr>
            <a:xfrm>
              <a:off x="9236479" y="5094733"/>
              <a:ext cx="230299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 err="1"/>
                <a:t>Infected</a:t>
              </a:r>
              <a:r>
                <a:rPr lang="fr-FR" sz="1200" dirty="0"/>
                <a:t> </a:t>
              </a:r>
              <a:r>
                <a:rPr lang="fr-FR" sz="1200" dirty="0" err="1"/>
                <a:t>labeled</a:t>
              </a:r>
              <a:r>
                <a:rPr lang="fr-FR" sz="1200" dirty="0"/>
                <a:t> thrombocytes</a:t>
              </a:r>
            </a:p>
          </p:txBody>
        </p:sp>
        <p:sp>
          <p:nvSpPr>
            <p:cNvPr id="32" name="ZoneTexte 31">
              <a:extLst>
                <a:ext uri="{FF2B5EF4-FFF2-40B4-BE49-F238E27FC236}">
                  <a16:creationId xmlns:a16="http://schemas.microsoft.com/office/drawing/2014/main" id="{86EFF6E0-B7BE-46C0-9302-C50A21ADD3AF}"/>
                </a:ext>
              </a:extLst>
            </p:cNvPr>
            <p:cNvSpPr txBox="1"/>
            <p:nvPr/>
          </p:nvSpPr>
          <p:spPr>
            <a:xfrm>
              <a:off x="9236479" y="6008165"/>
              <a:ext cx="248349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 err="1"/>
                <a:t>Infected</a:t>
              </a:r>
              <a:r>
                <a:rPr lang="fr-FR" sz="1200" dirty="0"/>
                <a:t> </a:t>
              </a:r>
              <a:r>
                <a:rPr lang="fr-FR" sz="1200" dirty="0" err="1"/>
                <a:t>unlabeled</a:t>
              </a:r>
              <a:r>
                <a:rPr lang="fr-FR" sz="1200" dirty="0"/>
                <a:t> </a:t>
              </a:r>
              <a:r>
                <a:rPr lang="fr-FR" sz="1200" dirty="0" err="1"/>
                <a:t>cells</a:t>
              </a:r>
              <a:endParaRPr lang="fr-FR" sz="1200" dirty="0"/>
            </a:p>
          </p:txBody>
        </p:sp>
        <p:sp>
          <p:nvSpPr>
            <p:cNvPr id="4" name="ZoneTexte 3">
              <a:extLst>
                <a:ext uri="{FF2B5EF4-FFF2-40B4-BE49-F238E27FC236}">
                  <a16:creationId xmlns:a16="http://schemas.microsoft.com/office/drawing/2014/main" id="{9238B342-6126-4A1A-9010-75B7981EF156}"/>
                </a:ext>
              </a:extLst>
            </p:cNvPr>
            <p:cNvSpPr txBox="1"/>
            <p:nvPr/>
          </p:nvSpPr>
          <p:spPr>
            <a:xfrm>
              <a:off x="1289017" y="877775"/>
              <a:ext cx="116477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/>
                <a:t>Isotype control</a:t>
              </a:r>
            </a:p>
          </p:txBody>
        </p:sp>
        <p:sp>
          <p:nvSpPr>
            <p:cNvPr id="33" name="ZoneTexte 32">
              <a:extLst>
                <a:ext uri="{FF2B5EF4-FFF2-40B4-BE49-F238E27FC236}">
                  <a16:creationId xmlns:a16="http://schemas.microsoft.com/office/drawing/2014/main" id="{97A99491-2D1B-497C-82EA-96D163338B05}"/>
                </a:ext>
              </a:extLst>
            </p:cNvPr>
            <p:cNvSpPr txBox="1"/>
            <p:nvPr/>
          </p:nvSpPr>
          <p:spPr>
            <a:xfrm>
              <a:off x="1309845" y="3054398"/>
              <a:ext cx="116477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/>
                <a:t>Isotype control</a:t>
              </a:r>
            </a:p>
          </p:txBody>
        </p:sp>
        <p:sp>
          <p:nvSpPr>
            <p:cNvPr id="34" name="ZoneTexte 33">
              <a:extLst>
                <a:ext uri="{FF2B5EF4-FFF2-40B4-BE49-F238E27FC236}">
                  <a16:creationId xmlns:a16="http://schemas.microsoft.com/office/drawing/2014/main" id="{BFA6729E-1564-4DE0-8970-E67A88961C76}"/>
                </a:ext>
              </a:extLst>
            </p:cNvPr>
            <p:cNvSpPr txBox="1"/>
            <p:nvPr/>
          </p:nvSpPr>
          <p:spPr>
            <a:xfrm>
              <a:off x="1253206" y="5301844"/>
              <a:ext cx="116477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/>
                <a:t>Isotype control</a:t>
              </a:r>
            </a:p>
          </p:txBody>
        </p:sp>
        <p:sp>
          <p:nvSpPr>
            <p:cNvPr id="35" name="ZoneTexte 34">
              <a:extLst>
                <a:ext uri="{FF2B5EF4-FFF2-40B4-BE49-F238E27FC236}">
                  <a16:creationId xmlns:a16="http://schemas.microsoft.com/office/drawing/2014/main" id="{BD24A082-87FB-40AB-9AEA-F3A7CE6818C7}"/>
                </a:ext>
              </a:extLst>
            </p:cNvPr>
            <p:cNvSpPr txBox="1"/>
            <p:nvPr/>
          </p:nvSpPr>
          <p:spPr>
            <a:xfrm>
              <a:off x="5633518" y="555457"/>
              <a:ext cx="179614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 err="1"/>
                <a:t>Labeled</a:t>
              </a:r>
              <a:r>
                <a:rPr lang="fr-FR" sz="1200" dirty="0"/>
                <a:t> thrombocytes</a:t>
              </a:r>
            </a:p>
          </p:txBody>
        </p:sp>
        <p:sp>
          <p:nvSpPr>
            <p:cNvPr id="36" name="ZoneTexte 35">
              <a:extLst>
                <a:ext uri="{FF2B5EF4-FFF2-40B4-BE49-F238E27FC236}">
                  <a16:creationId xmlns:a16="http://schemas.microsoft.com/office/drawing/2014/main" id="{4A201F4E-6FCB-43A9-AE3F-8A1950B5E89A}"/>
                </a:ext>
              </a:extLst>
            </p:cNvPr>
            <p:cNvSpPr txBox="1"/>
            <p:nvPr/>
          </p:nvSpPr>
          <p:spPr>
            <a:xfrm>
              <a:off x="5948814" y="6007831"/>
              <a:ext cx="131807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 err="1"/>
                <a:t>Unlabeled</a:t>
              </a:r>
              <a:r>
                <a:rPr lang="fr-FR" sz="1200" dirty="0"/>
                <a:t>  </a:t>
              </a:r>
              <a:r>
                <a:rPr lang="fr-FR" sz="1200" dirty="0" err="1"/>
                <a:t>cells</a:t>
              </a:r>
              <a:endParaRPr lang="fr-FR" sz="1200" dirty="0"/>
            </a:p>
          </p:txBody>
        </p:sp>
        <p:sp>
          <p:nvSpPr>
            <p:cNvPr id="37" name="ZoneTexte 36">
              <a:extLst>
                <a:ext uri="{FF2B5EF4-FFF2-40B4-BE49-F238E27FC236}">
                  <a16:creationId xmlns:a16="http://schemas.microsoft.com/office/drawing/2014/main" id="{0320534D-BA65-4729-A678-FC6B0FF2FCF9}"/>
                </a:ext>
              </a:extLst>
            </p:cNvPr>
            <p:cNvSpPr txBox="1"/>
            <p:nvPr/>
          </p:nvSpPr>
          <p:spPr>
            <a:xfrm>
              <a:off x="5955455" y="3822197"/>
              <a:ext cx="131807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 err="1"/>
                <a:t>Unlabeled</a:t>
              </a:r>
              <a:r>
                <a:rPr lang="fr-FR" sz="1200" dirty="0"/>
                <a:t>  </a:t>
              </a:r>
              <a:r>
                <a:rPr lang="fr-FR" sz="1200" dirty="0" err="1"/>
                <a:t>cells</a:t>
              </a:r>
              <a:endParaRPr lang="fr-FR" sz="1200" dirty="0"/>
            </a:p>
          </p:txBody>
        </p:sp>
      </p:grpSp>
      <p:sp>
        <p:nvSpPr>
          <p:cNvPr id="41" name="ZoneTexte 40">
            <a:extLst>
              <a:ext uri="{FF2B5EF4-FFF2-40B4-BE49-F238E27FC236}">
                <a16:creationId xmlns:a16="http://schemas.microsoft.com/office/drawing/2014/main" id="{767BB29B-24FB-4CE7-8123-E1A816F4AC24}"/>
              </a:ext>
            </a:extLst>
          </p:cNvPr>
          <p:cNvSpPr txBox="1"/>
          <p:nvPr/>
        </p:nvSpPr>
        <p:spPr>
          <a:xfrm>
            <a:off x="10205545" y="291263"/>
            <a:ext cx="16195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/>
              <a:t>S2 </a:t>
            </a:r>
            <a:r>
              <a:rPr lang="fr-FR" b="1" dirty="0" err="1"/>
              <a:t>Fig</a:t>
            </a:r>
            <a:endParaRPr lang="fr-FR" b="1" dirty="0"/>
          </a:p>
        </p:txBody>
      </p:sp>
      <p:pic>
        <p:nvPicPr>
          <p:cNvPr id="42" name="Image 41">
            <a:extLst>
              <a:ext uri="{FF2B5EF4-FFF2-40B4-BE49-F238E27FC236}">
                <a16:creationId xmlns:a16="http://schemas.microsoft.com/office/drawing/2014/main" id="{F9EA7C13-5791-4DBA-98E1-18BB7FD8FDD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75767" y="286662"/>
            <a:ext cx="1862093" cy="1949801"/>
          </a:xfrm>
          <a:prstGeom prst="rect">
            <a:avLst/>
          </a:prstGeom>
        </p:spPr>
      </p:pic>
      <p:pic>
        <p:nvPicPr>
          <p:cNvPr id="43" name="Image 42">
            <a:extLst>
              <a:ext uri="{FF2B5EF4-FFF2-40B4-BE49-F238E27FC236}">
                <a16:creationId xmlns:a16="http://schemas.microsoft.com/office/drawing/2014/main" id="{382003BC-AC78-47ED-B774-F7B2E6A9E39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62608" y="287161"/>
            <a:ext cx="1861139" cy="1948802"/>
          </a:xfrm>
          <a:prstGeom prst="rect">
            <a:avLst/>
          </a:prstGeom>
        </p:spPr>
      </p:pic>
      <p:pic>
        <p:nvPicPr>
          <p:cNvPr id="44" name="Picture 12" descr="C:\Users\trs-confocal\AppData\Local\Temp\tmp18816754396353135102.png">
            <a:extLst>
              <a:ext uri="{FF2B5EF4-FFF2-40B4-BE49-F238E27FC236}">
                <a16:creationId xmlns:a16="http://schemas.microsoft.com/office/drawing/2014/main" id="{995E0184-28E8-4893-8DD3-C92F7FB02AC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496756" y="2519295"/>
            <a:ext cx="1825043" cy="191100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5" name="Picture 8" descr="C:\Users\trs-confocal\AppData\Local\Temp\tmp14050491422967005666.png">
            <a:extLst>
              <a:ext uri="{FF2B5EF4-FFF2-40B4-BE49-F238E27FC236}">
                <a16:creationId xmlns:a16="http://schemas.microsoft.com/office/drawing/2014/main" id="{DF743B09-B070-4E0E-BCF1-D259783311E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476977" y="4713632"/>
            <a:ext cx="1864602" cy="195242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7" name="Picture 10" descr="C:\Users\trs-confocal\AppData\Local\Temp\tmp08830615847297510154.png">
            <a:extLst>
              <a:ext uri="{FF2B5EF4-FFF2-40B4-BE49-F238E27FC236}">
                <a16:creationId xmlns:a16="http://schemas.microsoft.com/office/drawing/2014/main" id="{16163216-CFC1-4CEF-9C08-3BC88299E96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95147" y="2485399"/>
            <a:ext cx="1862093" cy="1949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49" name="Groupe 48">
            <a:extLst>
              <a:ext uri="{FF2B5EF4-FFF2-40B4-BE49-F238E27FC236}">
                <a16:creationId xmlns:a16="http://schemas.microsoft.com/office/drawing/2014/main" id="{B43A1789-1ABD-4209-9DD9-19A2424476A6}"/>
              </a:ext>
            </a:extLst>
          </p:cNvPr>
          <p:cNvGrpSpPr/>
          <p:nvPr/>
        </p:nvGrpSpPr>
        <p:grpSpPr>
          <a:xfrm>
            <a:off x="2809098" y="4667496"/>
            <a:ext cx="1862092" cy="1949800"/>
            <a:chOff x="579429" y="367862"/>
            <a:chExt cx="5863412" cy="5957125"/>
          </a:xfrm>
        </p:grpSpPr>
        <p:grpSp>
          <p:nvGrpSpPr>
            <p:cNvPr id="50" name="Groupe 49">
              <a:extLst>
                <a:ext uri="{FF2B5EF4-FFF2-40B4-BE49-F238E27FC236}">
                  <a16:creationId xmlns:a16="http://schemas.microsoft.com/office/drawing/2014/main" id="{A25627C6-088B-4EF9-A2C9-7DA93B973C76}"/>
                </a:ext>
              </a:extLst>
            </p:cNvPr>
            <p:cNvGrpSpPr/>
            <p:nvPr/>
          </p:nvGrpSpPr>
          <p:grpSpPr>
            <a:xfrm>
              <a:off x="579429" y="367862"/>
              <a:ext cx="5863412" cy="5957125"/>
              <a:chOff x="579429" y="548579"/>
              <a:chExt cx="5516571" cy="5776408"/>
            </a:xfrm>
          </p:grpSpPr>
          <p:pic>
            <p:nvPicPr>
              <p:cNvPr id="52" name="Picture 10" descr="C:\Users\trs-confocal\AppData\Local\Temp\tmp08830615847297510154.png">
                <a:extLst>
                  <a:ext uri="{FF2B5EF4-FFF2-40B4-BE49-F238E27FC236}">
                    <a16:creationId xmlns:a16="http://schemas.microsoft.com/office/drawing/2014/main" id="{1CEC170B-906E-4969-82B7-1CB5643617E6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579429" y="548579"/>
                <a:ext cx="5516571" cy="5776408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53" name="Rectangle 52">
                <a:extLst>
                  <a:ext uri="{FF2B5EF4-FFF2-40B4-BE49-F238E27FC236}">
                    <a16:creationId xmlns:a16="http://schemas.microsoft.com/office/drawing/2014/main" id="{E4907791-2D2C-4BD2-99B4-2DAD52A557DC}"/>
                  </a:ext>
                </a:extLst>
              </p:cNvPr>
              <p:cNvSpPr/>
              <p:nvPr/>
            </p:nvSpPr>
            <p:spPr>
              <a:xfrm>
                <a:off x="1502979" y="714702"/>
                <a:ext cx="2364828" cy="409905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</p:grpSp>
        <p:pic>
          <p:nvPicPr>
            <p:cNvPr id="51" name="Picture 8" descr="C:\Users\trs-confocal\AppData\Local\Temp\tmp14050491422967005666.png">
              <a:extLst>
                <a:ext uri="{FF2B5EF4-FFF2-40B4-BE49-F238E27FC236}">
                  <a16:creationId xmlns:a16="http://schemas.microsoft.com/office/drawing/2014/main" id="{C1EB18DC-0148-4201-8E1A-95B78CDB3EDC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515" t="2872" r="27507" b="90041"/>
            <a:stretch/>
          </p:blipFill>
          <p:spPr bwMode="auto">
            <a:xfrm>
              <a:off x="725204" y="557049"/>
              <a:ext cx="3478924" cy="40990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</p:spTree>
    <p:extLst>
      <p:ext uri="{BB962C8B-B14F-4D97-AF65-F5344CB8AC3E}">
        <p14:creationId xmlns:p14="http://schemas.microsoft.com/office/powerpoint/2010/main" val="2777446464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5</Words>
  <Application>Microsoft Office PowerPoint</Application>
  <PresentationFormat>Grand écran</PresentationFormat>
  <Paragraphs>16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Sylvie Roche</dc:creator>
  <cp:lastModifiedBy>Sylvie Roche</cp:lastModifiedBy>
  <cp:revision>2</cp:revision>
  <dcterms:created xsi:type="dcterms:W3CDTF">2020-06-04T06:33:31Z</dcterms:created>
  <dcterms:modified xsi:type="dcterms:W3CDTF">2020-09-18T09:02:50Z</dcterms:modified>
</cp:coreProperties>
</file>